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6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AD0577-3BBD-59C2-D9E8-ECA15C5B59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2CBED2-72CD-0F77-22C5-DCD979E570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AE25ED-261D-328A-9EAC-450676D4F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9907EC-63B4-DD31-D21B-F61E3FFB5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FFA321-1E55-9B7C-A86F-9F66A86E3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328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72B7EF-5BF3-C282-29A9-0BF6DFC75F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C404A2-3D4E-C2D7-7E31-F0F26C7538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818445-4377-273D-1590-D0C07CF56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B2D906-DECE-A8FD-201D-D6889D1E7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5A1A2F-2262-9140-1ED1-B82A7BE6C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894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A01D4D-C04A-7B41-735B-015D59B814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358F45-4535-CC9F-2293-46A18A826F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F5F61A-3CA8-806E-AA89-7B3DDB7E3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0DB41-60F4-6891-BCDD-14E317339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4C649B-0698-CC1E-3988-7E579C8DB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043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E9A6F3-1188-E256-A849-244677FAC3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DD2054-3965-B3B1-605B-D8F82CA723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274BDE-A10B-615A-BACC-32A548E5A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390CAD-89E0-86AF-35CE-D406E0C6D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4C568C-938B-6FA8-A82B-45E274A88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427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53E11D-3BD5-D0A9-ADD7-0E1E4BE11C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506576-0579-2EB3-7649-3E0EB06E84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F54191-9E55-1279-20F6-13FF4C648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F3E469-7CAD-EA00-6252-638ECC7A6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D92533-94B4-52E2-2D4A-DB63CED36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34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DF212C-FFA3-9061-9C15-11907209B4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ED0DBF-6AD2-03C8-A84B-E06AD9F03B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0BA2F4-35A1-42E9-118D-DAFD940E98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0FC39F-C28E-5D43-CFD0-C8A7BEA49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9DEEC9-AD4D-81D5-F9C4-CFEF9DE0E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870F65-E145-AD59-6465-1B5327942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592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B49972-C0D3-AF11-E421-77D575B9D0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F805C5-886A-B30C-C1DB-374C1FE55C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95B131-0C05-B4EA-682B-205CE3D0FA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7951E0-582B-AD1B-8B66-56969AF171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986C90-AA5E-C5F9-F793-6E5F9AE4C2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E41099-7233-3346-1271-BD98E5AFA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66A6226-127F-A550-F255-B9780B1A2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BA5FEE-E9AB-DAEF-B2EB-0DB7C4C5A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553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D6EC52-EBCF-FEC7-EA46-96E218681E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7EE9E97-F3C8-102B-50BE-7DCA7B584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501044-C966-E021-33D4-AB08EAFBB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451D30-EE87-1702-E3B2-A114C56970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17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8C5B5F-086D-8BF4-688D-D891C2D600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DC27D0-EFF8-CE23-C44C-C24C15118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A1627B-74C9-71D5-ECC0-2DC8673DA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679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DA8D6F-2E6F-E09E-9E48-344F41B26E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0C37C3-D233-E210-728A-00CF3378FF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492D5F-324D-FF8B-787C-69D326F1F1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3F0A09-FCD2-7874-54ED-937ECA273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B0941A-EFD3-7245-0FD0-61B4F401B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A8E163-61E8-48F4-40D8-FBDBF7955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038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223DBA-3625-E7E8-5ECA-B2D8E813D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13873C-4F4C-F39A-49A6-4A49946A7D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D815B1-DFED-FB47-A811-6D37F051D8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69DBC1-ADA7-A80F-5B60-B48F326BA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BB4F38-335C-1864-178A-3641A198B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65E628-30B4-5A83-E35F-D4EABC3FE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023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C6C466-92E2-63AD-31A9-E3DB37BBC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82871A-81BF-51DD-04B0-27990D5B2F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5DCE44-0D52-AC41-9527-74979FDB74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7EE53-366C-B44B-A31A-B425F548BD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9B6106-5294-8410-A396-265CC033FD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471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D56CA629-879E-CED3-3678-6A3A92A087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6337" y="1737834"/>
            <a:ext cx="3182768" cy="513349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6E89DAC6-2CEB-6F1F-2EF1-E886E408D1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536766"/>
          </a:xfrm>
        </p:spPr>
        <p:txBody>
          <a:bodyPr>
            <a:normAutofit/>
          </a:bodyPr>
          <a:lstStyle/>
          <a:p>
            <a:r>
              <a:rPr lang="en-US" sz="2400" dirty="0"/>
              <a:t>Supplemental Figure 1: Sorghum Stem Development and SEM tissue collectio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52CB922-DF45-85CF-254C-B84F164B7591}"/>
              </a:ext>
            </a:extLst>
          </p:cNvPr>
          <p:cNvSpPr txBox="1"/>
          <p:nvPr/>
        </p:nvSpPr>
        <p:spPr>
          <a:xfrm>
            <a:off x="2691298" y="2780784"/>
            <a:ext cx="1767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 1-Phytomer 4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C45CF1D-B5B8-1459-52A3-F067613E9C9B}"/>
              </a:ext>
            </a:extLst>
          </p:cNvPr>
          <p:cNvCxnSpPr>
            <a:cxnSpLocks/>
          </p:cNvCxnSpPr>
          <p:nvPr/>
        </p:nvCxnSpPr>
        <p:spPr>
          <a:xfrm flipH="1">
            <a:off x="4736306" y="2661920"/>
            <a:ext cx="1952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AE14D2D5-54DF-11E8-D4F6-A557C0A3C9D2}"/>
              </a:ext>
            </a:extLst>
          </p:cNvPr>
          <p:cNvCxnSpPr>
            <a:cxnSpLocks/>
          </p:cNvCxnSpPr>
          <p:nvPr/>
        </p:nvCxnSpPr>
        <p:spPr>
          <a:xfrm flipH="1">
            <a:off x="4736306" y="2852221"/>
            <a:ext cx="2047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0CB3AE4E-C378-901E-F6AF-3D2DCC475968}"/>
              </a:ext>
            </a:extLst>
          </p:cNvPr>
          <p:cNvCxnSpPr>
            <a:cxnSpLocks/>
          </p:cNvCxnSpPr>
          <p:nvPr/>
        </p:nvCxnSpPr>
        <p:spPr>
          <a:xfrm>
            <a:off x="4736306" y="2661920"/>
            <a:ext cx="0" cy="19030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5F2432D-310D-108B-19F6-F7DBE942B10C}"/>
              </a:ext>
            </a:extLst>
          </p:cNvPr>
          <p:cNvCxnSpPr>
            <a:cxnSpLocks/>
            <a:endCxn id="35" idx="3"/>
          </p:cNvCxnSpPr>
          <p:nvPr/>
        </p:nvCxnSpPr>
        <p:spPr>
          <a:xfrm flipH="1" flipV="1">
            <a:off x="4311584" y="2642715"/>
            <a:ext cx="424722" cy="12056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DA2EC0A5-EEFB-5EE1-BEF8-647FB73C8435}"/>
              </a:ext>
            </a:extLst>
          </p:cNvPr>
          <p:cNvSpPr txBox="1"/>
          <p:nvPr/>
        </p:nvSpPr>
        <p:spPr>
          <a:xfrm>
            <a:off x="2851504" y="2458049"/>
            <a:ext cx="1460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hytomer 1-3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E74D58A1-8992-089E-1FC0-C0DE15BB2A3C}"/>
              </a:ext>
            </a:extLst>
          </p:cNvPr>
          <p:cNvCxnSpPr>
            <a:cxnSpLocks/>
          </p:cNvCxnSpPr>
          <p:nvPr/>
        </p:nvCxnSpPr>
        <p:spPr>
          <a:xfrm flipH="1">
            <a:off x="4747393" y="3052899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B7786D2C-D756-6E27-8E36-632870BE22AD}"/>
              </a:ext>
            </a:extLst>
          </p:cNvPr>
          <p:cNvCxnSpPr/>
          <p:nvPr/>
        </p:nvCxnSpPr>
        <p:spPr>
          <a:xfrm flipH="1">
            <a:off x="4748292" y="2876086"/>
            <a:ext cx="2047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02741F66-11D8-1C3A-BD53-5A45DA37BF8A}"/>
              </a:ext>
            </a:extLst>
          </p:cNvPr>
          <p:cNvCxnSpPr>
            <a:cxnSpLocks/>
          </p:cNvCxnSpPr>
          <p:nvPr/>
        </p:nvCxnSpPr>
        <p:spPr>
          <a:xfrm flipV="1">
            <a:off x="4747393" y="2873772"/>
            <a:ext cx="0" cy="1791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D9B725A1-5590-FEA8-A8C8-C4DB3EE408EE}"/>
              </a:ext>
            </a:extLst>
          </p:cNvPr>
          <p:cNvCxnSpPr>
            <a:cxnSpLocks/>
          </p:cNvCxnSpPr>
          <p:nvPr/>
        </p:nvCxnSpPr>
        <p:spPr>
          <a:xfrm flipH="1">
            <a:off x="4473099" y="2954534"/>
            <a:ext cx="275193" cy="214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BEF0FF81-E99E-ED27-C040-B13391FC7686}"/>
              </a:ext>
            </a:extLst>
          </p:cNvPr>
          <p:cNvSpPr txBox="1"/>
          <p:nvPr/>
        </p:nvSpPr>
        <p:spPr>
          <a:xfrm>
            <a:off x="2693133" y="3150116"/>
            <a:ext cx="1767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 2-Phytomer 5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334702D0-BC0E-4EBB-3D0F-23CC0A080DD2}"/>
              </a:ext>
            </a:extLst>
          </p:cNvPr>
          <p:cNvCxnSpPr>
            <a:cxnSpLocks/>
          </p:cNvCxnSpPr>
          <p:nvPr/>
        </p:nvCxnSpPr>
        <p:spPr>
          <a:xfrm flipH="1">
            <a:off x="4741069" y="3123486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C64B0D5-3F9E-EA1F-B934-43DF29C388F2}"/>
              </a:ext>
            </a:extLst>
          </p:cNvPr>
          <p:cNvCxnSpPr>
            <a:cxnSpLocks/>
          </p:cNvCxnSpPr>
          <p:nvPr/>
        </p:nvCxnSpPr>
        <p:spPr>
          <a:xfrm flipH="1">
            <a:off x="4736307" y="3584497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5BE98E52-5D06-F4A0-A5D8-E6BE9D95BC38}"/>
              </a:ext>
            </a:extLst>
          </p:cNvPr>
          <p:cNvCxnSpPr>
            <a:cxnSpLocks/>
          </p:cNvCxnSpPr>
          <p:nvPr/>
        </p:nvCxnSpPr>
        <p:spPr>
          <a:xfrm flipV="1">
            <a:off x="4736307" y="3123486"/>
            <a:ext cx="4762" cy="46101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71FDF908-DF77-3C15-8F31-99D80B13358A}"/>
              </a:ext>
            </a:extLst>
          </p:cNvPr>
          <p:cNvCxnSpPr>
            <a:cxnSpLocks/>
          </p:cNvCxnSpPr>
          <p:nvPr/>
        </p:nvCxnSpPr>
        <p:spPr>
          <a:xfrm flipH="1">
            <a:off x="4510088" y="3334782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C1ADE5CB-9693-6870-6098-4238E88906C6}"/>
              </a:ext>
            </a:extLst>
          </p:cNvPr>
          <p:cNvSpPr txBox="1"/>
          <p:nvPr/>
        </p:nvSpPr>
        <p:spPr>
          <a:xfrm>
            <a:off x="2691297" y="3986059"/>
            <a:ext cx="1767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 3-Phytomer 6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38E7325-8F9A-4B76-1CA6-E6A90FDDC9BA}"/>
              </a:ext>
            </a:extLst>
          </p:cNvPr>
          <p:cNvSpPr txBox="1"/>
          <p:nvPr/>
        </p:nvSpPr>
        <p:spPr>
          <a:xfrm>
            <a:off x="2691296" y="5418857"/>
            <a:ext cx="1767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 4-Phytomer 7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D38AD691-6781-012A-B0E0-456140975F1E}"/>
              </a:ext>
            </a:extLst>
          </p:cNvPr>
          <p:cNvCxnSpPr>
            <a:cxnSpLocks/>
          </p:cNvCxnSpPr>
          <p:nvPr/>
        </p:nvCxnSpPr>
        <p:spPr>
          <a:xfrm flipH="1">
            <a:off x="4710112" y="3689272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F33F0A7E-166D-2123-5C3B-62C7B59B7D59}"/>
              </a:ext>
            </a:extLst>
          </p:cNvPr>
          <p:cNvCxnSpPr>
            <a:cxnSpLocks/>
          </p:cNvCxnSpPr>
          <p:nvPr/>
        </p:nvCxnSpPr>
        <p:spPr>
          <a:xfrm flipH="1">
            <a:off x="4701778" y="4741785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C6A8C8CC-A4C7-DCD3-3FF6-EFFDE106F1D9}"/>
              </a:ext>
            </a:extLst>
          </p:cNvPr>
          <p:cNvCxnSpPr>
            <a:cxnSpLocks/>
          </p:cNvCxnSpPr>
          <p:nvPr/>
        </p:nvCxnSpPr>
        <p:spPr>
          <a:xfrm flipH="1">
            <a:off x="4623197" y="4917997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38EDEB26-0912-18EE-A3CA-5016A6C616C7}"/>
              </a:ext>
            </a:extLst>
          </p:cNvPr>
          <p:cNvCxnSpPr>
            <a:cxnSpLocks/>
          </p:cNvCxnSpPr>
          <p:nvPr/>
        </p:nvCxnSpPr>
        <p:spPr>
          <a:xfrm flipH="1">
            <a:off x="4627960" y="6365797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A775E76A-A763-7B3C-9383-07218524415E}"/>
              </a:ext>
            </a:extLst>
          </p:cNvPr>
          <p:cNvCxnSpPr>
            <a:cxnSpLocks/>
          </p:cNvCxnSpPr>
          <p:nvPr/>
        </p:nvCxnSpPr>
        <p:spPr>
          <a:xfrm flipV="1">
            <a:off x="4701778" y="3689272"/>
            <a:ext cx="0" cy="10525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889CDEB9-40F5-A7BC-13CA-B21FDE8C466C}"/>
              </a:ext>
            </a:extLst>
          </p:cNvPr>
          <p:cNvCxnSpPr>
            <a:cxnSpLocks/>
          </p:cNvCxnSpPr>
          <p:nvPr/>
        </p:nvCxnSpPr>
        <p:spPr>
          <a:xfrm flipH="1">
            <a:off x="4475559" y="4179809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46180B90-60A3-C877-6D9C-8133DD4EA43D}"/>
              </a:ext>
            </a:extLst>
          </p:cNvPr>
          <p:cNvCxnSpPr>
            <a:cxnSpLocks/>
          </p:cNvCxnSpPr>
          <p:nvPr/>
        </p:nvCxnSpPr>
        <p:spPr>
          <a:xfrm flipV="1">
            <a:off x="4623197" y="4917997"/>
            <a:ext cx="0" cy="14478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EA6DF6FF-EE08-F84E-FDFE-388734C2B852}"/>
              </a:ext>
            </a:extLst>
          </p:cNvPr>
          <p:cNvCxnSpPr>
            <a:cxnSpLocks/>
          </p:cNvCxnSpPr>
          <p:nvPr/>
        </p:nvCxnSpPr>
        <p:spPr>
          <a:xfrm flipH="1">
            <a:off x="4396978" y="5603797"/>
            <a:ext cx="22621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C2119700-9307-4C75-C885-B846EA010D99}"/>
              </a:ext>
            </a:extLst>
          </p:cNvPr>
          <p:cNvSpPr txBox="1"/>
          <p:nvPr/>
        </p:nvSpPr>
        <p:spPr>
          <a:xfrm>
            <a:off x="5499692" y="2377048"/>
            <a:ext cx="13898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ascent Leaf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1B5EE53-F9B3-C6EF-6F02-E143AA724F03}"/>
              </a:ext>
            </a:extLst>
          </p:cNvPr>
          <p:cNvCxnSpPr/>
          <p:nvPr/>
        </p:nvCxnSpPr>
        <p:spPr>
          <a:xfrm>
            <a:off x="5543550" y="3003110"/>
            <a:ext cx="4438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24A5E0FD-AD06-6583-C500-B5FA3ED8D0EB}"/>
              </a:ext>
            </a:extLst>
          </p:cNvPr>
          <p:cNvCxnSpPr>
            <a:cxnSpLocks/>
            <a:endCxn id="14" idx="1"/>
          </p:cNvCxnSpPr>
          <p:nvPr/>
        </p:nvCxnSpPr>
        <p:spPr>
          <a:xfrm>
            <a:off x="5543550" y="3296682"/>
            <a:ext cx="392246" cy="664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3595410-C2E7-0696-0E6E-FC30115546D9}"/>
              </a:ext>
            </a:extLst>
          </p:cNvPr>
          <p:cNvCxnSpPr/>
          <p:nvPr/>
        </p:nvCxnSpPr>
        <p:spPr>
          <a:xfrm>
            <a:off x="5543550" y="3222607"/>
            <a:ext cx="4438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BC7E1DAC-49E9-3549-E900-82DBB5C1A9D4}"/>
              </a:ext>
            </a:extLst>
          </p:cNvPr>
          <p:cNvCxnSpPr>
            <a:cxnSpLocks/>
            <a:endCxn id="16" idx="1"/>
          </p:cNvCxnSpPr>
          <p:nvPr/>
        </p:nvCxnSpPr>
        <p:spPr>
          <a:xfrm flipV="1">
            <a:off x="5543550" y="3617299"/>
            <a:ext cx="380608" cy="21865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6D104DB-8F47-A007-4540-2A8AE645B3CA}"/>
              </a:ext>
            </a:extLst>
          </p:cNvPr>
          <p:cNvCxnSpPr/>
          <p:nvPr/>
        </p:nvCxnSpPr>
        <p:spPr>
          <a:xfrm>
            <a:off x="5589511" y="5044440"/>
            <a:ext cx="4438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8F24104-E036-C9EE-4969-94EB8C775971}"/>
              </a:ext>
            </a:extLst>
          </p:cNvPr>
          <p:cNvCxnSpPr/>
          <p:nvPr/>
        </p:nvCxnSpPr>
        <p:spPr>
          <a:xfrm>
            <a:off x="5589511" y="5330552"/>
            <a:ext cx="4438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E1457B45-8DCE-BA03-8F64-ADBACAB2A86A}"/>
              </a:ext>
            </a:extLst>
          </p:cNvPr>
          <p:cNvSpPr txBox="1"/>
          <p:nvPr/>
        </p:nvSpPr>
        <p:spPr>
          <a:xfrm>
            <a:off x="5940221" y="2867978"/>
            <a:ext cx="873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gure 1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0FEBD29-8053-49CC-3C8D-1181E356A07F}"/>
              </a:ext>
            </a:extLst>
          </p:cNvPr>
          <p:cNvSpPr txBox="1"/>
          <p:nvPr/>
        </p:nvSpPr>
        <p:spPr>
          <a:xfrm>
            <a:off x="5937191" y="3065382"/>
            <a:ext cx="8651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gure 1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5A6CFDF-9917-AAF8-6266-366DD74D37F8}"/>
              </a:ext>
            </a:extLst>
          </p:cNvPr>
          <p:cNvSpPr txBox="1"/>
          <p:nvPr/>
        </p:nvSpPr>
        <p:spPr>
          <a:xfrm>
            <a:off x="5935796" y="3209272"/>
            <a:ext cx="866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gure 1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5A036B-1C21-2409-924A-C7B125FC0232}"/>
              </a:ext>
            </a:extLst>
          </p:cNvPr>
          <p:cNvSpPr txBox="1"/>
          <p:nvPr/>
        </p:nvSpPr>
        <p:spPr>
          <a:xfrm>
            <a:off x="5924158" y="3463410"/>
            <a:ext cx="10158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gure 1D-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A76063E-95ED-B44F-877A-0440FDBE0CFB}"/>
              </a:ext>
            </a:extLst>
          </p:cNvPr>
          <p:cNvSpPr txBox="1"/>
          <p:nvPr/>
        </p:nvSpPr>
        <p:spPr>
          <a:xfrm>
            <a:off x="5987368" y="4878230"/>
            <a:ext cx="873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gure 2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2E77E99-633B-6F54-EB04-C87B766B30EB}"/>
              </a:ext>
            </a:extLst>
          </p:cNvPr>
          <p:cNvSpPr txBox="1"/>
          <p:nvPr/>
        </p:nvSpPr>
        <p:spPr>
          <a:xfrm>
            <a:off x="5998926" y="5171500"/>
            <a:ext cx="866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gure 2B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935F332-9729-1607-2767-2E8BAED4E5D8}"/>
              </a:ext>
            </a:extLst>
          </p:cNvPr>
          <p:cNvCxnSpPr/>
          <p:nvPr/>
        </p:nvCxnSpPr>
        <p:spPr>
          <a:xfrm>
            <a:off x="5589511" y="5600349"/>
            <a:ext cx="4438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E5763C9E-33A8-FE7F-2764-3138944DA2C4}"/>
              </a:ext>
            </a:extLst>
          </p:cNvPr>
          <p:cNvSpPr txBox="1"/>
          <p:nvPr/>
        </p:nvSpPr>
        <p:spPr>
          <a:xfrm>
            <a:off x="6000338" y="5446460"/>
            <a:ext cx="8651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gure 2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083D1FA-12B8-AB55-05E8-96BC5EF86F40}"/>
              </a:ext>
            </a:extLst>
          </p:cNvPr>
          <p:cNvSpPr txBox="1"/>
          <p:nvPr/>
        </p:nvSpPr>
        <p:spPr>
          <a:xfrm>
            <a:off x="3472808" y="1796714"/>
            <a:ext cx="31235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gure 3A-F Are below visible internodes</a:t>
            </a:r>
          </a:p>
        </p:txBody>
      </p:sp>
      <p:sp>
        <p:nvSpPr>
          <p:cNvPr id="22" name="Arrow: Right 21">
            <a:extLst>
              <a:ext uri="{FF2B5EF4-FFF2-40B4-BE49-F238E27FC236}">
                <a16:creationId xmlns:a16="http://schemas.microsoft.com/office/drawing/2014/main" id="{05030F52-2DAA-9A1F-33A0-CED6DD466531}"/>
              </a:ext>
            </a:extLst>
          </p:cNvPr>
          <p:cNvSpPr/>
          <p:nvPr/>
        </p:nvSpPr>
        <p:spPr>
          <a:xfrm rot="5400000">
            <a:off x="5844552" y="4242281"/>
            <a:ext cx="4349354" cy="22622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39B5101-016A-71B7-F273-3239EBFA8888}"/>
              </a:ext>
            </a:extLst>
          </p:cNvPr>
          <p:cNvSpPr txBox="1"/>
          <p:nvPr/>
        </p:nvSpPr>
        <p:spPr>
          <a:xfrm>
            <a:off x="7022634" y="1766731"/>
            <a:ext cx="2039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Youngest Phytome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A47D12E-E4A0-1354-32BE-02CA0DEEBC41}"/>
              </a:ext>
            </a:extLst>
          </p:cNvPr>
          <p:cNvSpPr txBox="1"/>
          <p:nvPr/>
        </p:nvSpPr>
        <p:spPr>
          <a:xfrm>
            <a:off x="7199721" y="6565655"/>
            <a:ext cx="1795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Oldest Phytomer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024C7A3-6E01-577F-C85F-C0697BC3767A}"/>
              </a:ext>
            </a:extLst>
          </p:cNvPr>
          <p:cNvSpPr txBox="1"/>
          <p:nvPr/>
        </p:nvSpPr>
        <p:spPr>
          <a:xfrm>
            <a:off x="5912936" y="4379442"/>
            <a:ext cx="10967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ell Divisio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2A43970-12C1-1313-3430-5B5222FFFF78}"/>
              </a:ext>
            </a:extLst>
          </p:cNvPr>
          <p:cNvSpPr txBox="1"/>
          <p:nvPr/>
        </p:nvSpPr>
        <p:spPr>
          <a:xfrm>
            <a:off x="5915080" y="4099395"/>
            <a:ext cx="12924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ell Elongatio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C2668CC-AEC0-84E7-E133-414A167BA5CF}"/>
              </a:ext>
            </a:extLst>
          </p:cNvPr>
          <p:cNvSpPr txBox="1"/>
          <p:nvPr/>
        </p:nvSpPr>
        <p:spPr>
          <a:xfrm>
            <a:off x="5915503" y="3692910"/>
            <a:ext cx="13475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ell Maturation</a:t>
            </a:r>
          </a:p>
        </p:txBody>
      </p:sp>
      <p:sp>
        <p:nvSpPr>
          <p:cNvPr id="30" name="Arrow: Right 29">
            <a:extLst>
              <a:ext uri="{FF2B5EF4-FFF2-40B4-BE49-F238E27FC236}">
                <a16:creationId xmlns:a16="http://schemas.microsoft.com/office/drawing/2014/main" id="{83DFB18E-095E-616B-A05D-C413CD5F7EF9}"/>
              </a:ext>
            </a:extLst>
          </p:cNvPr>
          <p:cNvSpPr/>
          <p:nvPr/>
        </p:nvSpPr>
        <p:spPr>
          <a:xfrm rot="16200000">
            <a:off x="6835357" y="4029504"/>
            <a:ext cx="899410" cy="22622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7BFDB00-B686-F5C6-C3D0-F42597E0E8FD}"/>
              </a:ext>
            </a:extLst>
          </p:cNvPr>
          <p:cNvSpPr txBox="1"/>
          <p:nvPr/>
        </p:nvSpPr>
        <p:spPr>
          <a:xfrm rot="16200000">
            <a:off x="6933118" y="3977862"/>
            <a:ext cx="13271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ifferentiation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70A71836-8FB3-5698-C7FF-B05DB8FA5F77}"/>
              </a:ext>
            </a:extLst>
          </p:cNvPr>
          <p:cNvCxnSpPr>
            <a:cxnSpLocks/>
          </p:cNvCxnSpPr>
          <p:nvPr/>
        </p:nvCxnSpPr>
        <p:spPr>
          <a:xfrm flipV="1">
            <a:off x="5642846" y="6096196"/>
            <a:ext cx="346803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B092505-5B7E-BCE5-4176-4CBA0727580F}"/>
              </a:ext>
            </a:extLst>
          </p:cNvPr>
          <p:cNvCxnSpPr>
            <a:cxnSpLocks/>
          </p:cNvCxnSpPr>
          <p:nvPr/>
        </p:nvCxnSpPr>
        <p:spPr>
          <a:xfrm flipV="1">
            <a:off x="5642845" y="6326130"/>
            <a:ext cx="346803" cy="59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1F326F66-AFD2-F196-B687-A1277FCC4620}"/>
              </a:ext>
            </a:extLst>
          </p:cNvPr>
          <p:cNvSpPr txBox="1"/>
          <p:nvPr/>
        </p:nvSpPr>
        <p:spPr>
          <a:xfrm>
            <a:off x="5965680" y="5942307"/>
            <a:ext cx="17128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ntercalary Meristem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D0D4EB9-53C7-EEA4-5888-CA7281BC10FB}"/>
              </a:ext>
            </a:extLst>
          </p:cNvPr>
          <p:cNvSpPr txBox="1"/>
          <p:nvPr/>
        </p:nvSpPr>
        <p:spPr>
          <a:xfrm>
            <a:off x="5958060" y="6181835"/>
            <a:ext cx="17535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ulvinus/Nodal Roots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E77016BE-30F4-AE32-49F1-3C5C8ECF1C11}"/>
              </a:ext>
            </a:extLst>
          </p:cNvPr>
          <p:cNvCxnSpPr/>
          <p:nvPr/>
        </p:nvCxnSpPr>
        <p:spPr>
          <a:xfrm>
            <a:off x="5586971" y="4805680"/>
            <a:ext cx="4438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DD3633C2-0059-9B5E-DC27-CE9E7426CA53}"/>
              </a:ext>
            </a:extLst>
          </p:cNvPr>
          <p:cNvSpPr txBox="1"/>
          <p:nvPr/>
        </p:nvSpPr>
        <p:spPr>
          <a:xfrm>
            <a:off x="5985510" y="4639287"/>
            <a:ext cx="11212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odal Plexus</a:t>
            </a:r>
          </a:p>
        </p:txBody>
      </p:sp>
    </p:spTree>
    <p:extLst>
      <p:ext uri="{BB962C8B-B14F-4D97-AF65-F5344CB8AC3E}">
        <p14:creationId xmlns:p14="http://schemas.microsoft.com/office/powerpoint/2010/main" val="1906866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1: Sorghum Stem Development and SEM tissue collec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: Sorghum Stem Development and SEM tissue collection</dc:title>
  <dc:creator>Robert Chemelewski</dc:creator>
  <cp:lastModifiedBy>Abby Rassette</cp:lastModifiedBy>
  <cp:revision>1</cp:revision>
  <dcterms:created xsi:type="dcterms:W3CDTF">2023-05-23T18:32:28Z</dcterms:created>
  <dcterms:modified xsi:type="dcterms:W3CDTF">2023-09-11T14:31:31Z</dcterms:modified>
</cp:coreProperties>
</file>